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806" autoAdjust="0"/>
  </p:normalViewPr>
  <p:slideViewPr>
    <p:cSldViewPr>
      <p:cViewPr varScale="1">
        <p:scale>
          <a:sx n="46" d="100"/>
          <a:sy n="46" d="100"/>
        </p:scale>
        <p:origin x="2112" y="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-27384" y="35496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7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-27384" y="377548"/>
            <a:ext cx="3519237" cy="2250236"/>
            <a:chOff x="116632" y="377548"/>
            <a:chExt cx="3519237" cy="2250236"/>
          </a:xfrm>
        </p:grpSpPr>
        <p:pic>
          <p:nvPicPr>
            <p:cNvPr id="3075" name="Picture 3" descr="C:\Users\ImageQuant\Desktop\Sonomi\Fstl1\2. NRFB\NRFB 10-17\rec Fstl1 1\p-ERK 12\p-ERK 12 20141023_1440_5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6632" y="377548"/>
              <a:ext cx="3519237" cy="225023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3" name="正方形/長方形 22"/>
            <p:cNvSpPr/>
            <p:nvPr/>
          </p:nvSpPr>
          <p:spPr>
            <a:xfrm>
              <a:off x="855141" y="1072966"/>
              <a:ext cx="894226" cy="268199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テキスト ボックス 23"/>
            <p:cNvSpPr txBox="1"/>
            <p:nvPr/>
          </p:nvSpPr>
          <p:spPr>
            <a:xfrm>
              <a:off x="567730" y="803030"/>
              <a:ext cx="9108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ERK1/2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3238081" y="341951"/>
            <a:ext cx="3519237" cy="2243809"/>
            <a:chOff x="3238081" y="341951"/>
            <a:chExt cx="3519237" cy="2243809"/>
          </a:xfrm>
        </p:grpSpPr>
        <p:pic>
          <p:nvPicPr>
            <p:cNvPr id="3076" name="Picture 4" descr="C:\Users\ImageQuant\Desktop\Sonomi\Fstl1\2. NRFB\NRFB 10-17\rec Fstl1 1\t-ERK\t-ERK 20141027_1231_3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38081" y="341951"/>
              <a:ext cx="3519237" cy="224380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6" name="正方形/長方形 22"/>
            <p:cNvSpPr/>
            <p:nvPr/>
          </p:nvSpPr>
          <p:spPr>
            <a:xfrm>
              <a:off x="3869952" y="1207457"/>
              <a:ext cx="894226" cy="268199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テキスト ボックス 23"/>
            <p:cNvSpPr txBox="1"/>
            <p:nvPr/>
          </p:nvSpPr>
          <p:spPr>
            <a:xfrm>
              <a:off x="3582541" y="937521"/>
              <a:ext cx="7569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K1/2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188640" y="2555776"/>
            <a:ext cx="3199306" cy="2051496"/>
            <a:chOff x="188640" y="2555776"/>
            <a:chExt cx="3199306" cy="2051496"/>
          </a:xfrm>
        </p:grpSpPr>
        <p:pic>
          <p:nvPicPr>
            <p:cNvPr id="3077" name="Picture 5" descr="C:\Users\ImageQuant\Desktop\Sonomi\Fstl1\2. NRFB\NRFB 10-17\rec Fstl1 1\tubulin\tubulin 20141022_1328_6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8640" y="2555776"/>
              <a:ext cx="3199306" cy="205149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0" name="正方形/長方形 22"/>
            <p:cNvSpPr/>
            <p:nvPr/>
          </p:nvSpPr>
          <p:spPr>
            <a:xfrm>
              <a:off x="770822" y="3166702"/>
              <a:ext cx="812933" cy="268199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テキスト ボックス 23"/>
            <p:cNvSpPr txBox="1"/>
            <p:nvPr/>
          </p:nvSpPr>
          <p:spPr>
            <a:xfrm>
              <a:off x="484165" y="2896766"/>
              <a:ext cx="7239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47" name="Straight Connector 46"/>
          <p:cNvCxnSpPr/>
          <p:nvPr/>
        </p:nvCxnSpPr>
        <p:spPr>
          <a:xfrm>
            <a:off x="179115" y="4624958"/>
            <a:ext cx="6543203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" name="Group 7"/>
          <p:cNvGrpSpPr/>
          <p:nvPr/>
        </p:nvGrpSpPr>
        <p:grpSpPr>
          <a:xfrm>
            <a:off x="188640" y="4716016"/>
            <a:ext cx="3199306" cy="2132872"/>
            <a:chOff x="188640" y="4716016"/>
            <a:chExt cx="3199306" cy="2132872"/>
          </a:xfrm>
        </p:grpSpPr>
        <p:pic>
          <p:nvPicPr>
            <p:cNvPr id="3078" name="Picture 6" descr="C:\Users\ImageQuant\Desktop\Sonomi\Fstl1\2. NRFB\NRFB 5-1-2015\15min redo 5-5-2015\p-ERK\p-ERK high 20150505_1406_1_4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8640" y="4716016"/>
              <a:ext cx="3199306" cy="213287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8" name="正方形/長方形 22"/>
            <p:cNvSpPr/>
            <p:nvPr/>
          </p:nvSpPr>
          <p:spPr>
            <a:xfrm>
              <a:off x="773221" y="5552491"/>
              <a:ext cx="983649" cy="268199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テキスト ボックス 23"/>
            <p:cNvSpPr txBox="1"/>
            <p:nvPr/>
          </p:nvSpPr>
          <p:spPr>
            <a:xfrm>
              <a:off x="495904" y="5282555"/>
              <a:ext cx="9108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ERK1/2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4" name="テキスト ボックス 1"/>
          <p:cNvSpPr txBox="1"/>
          <p:nvPr/>
        </p:nvSpPr>
        <p:spPr>
          <a:xfrm>
            <a:off x="19700" y="4634716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7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3356992" y="4692023"/>
            <a:ext cx="3199306" cy="2132873"/>
            <a:chOff x="3356992" y="4692023"/>
            <a:chExt cx="3199306" cy="2132873"/>
          </a:xfrm>
        </p:grpSpPr>
        <p:pic>
          <p:nvPicPr>
            <p:cNvPr id="3079" name="Picture 7" descr="C:\Users\ImageQuant\Desktop\Sonomi\Fstl1\2. NRFB\NRFB 5-1-2015\15min redo 5-5-2015\ERK\ERK 20150506_1045_1_5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56992" y="4692023"/>
              <a:ext cx="3199306" cy="213287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2" name="正方形/長方形 22"/>
            <p:cNvSpPr/>
            <p:nvPr/>
          </p:nvSpPr>
          <p:spPr>
            <a:xfrm>
              <a:off x="3995619" y="5499533"/>
              <a:ext cx="983649" cy="268199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テキスト ボックス 23"/>
            <p:cNvSpPr txBox="1"/>
            <p:nvPr/>
          </p:nvSpPr>
          <p:spPr>
            <a:xfrm>
              <a:off x="3718302" y="5229597"/>
              <a:ext cx="7569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K1/2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85678" y="6876256"/>
            <a:ext cx="3199306" cy="2132872"/>
            <a:chOff x="85678" y="6876256"/>
            <a:chExt cx="3199306" cy="2132872"/>
          </a:xfrm>
        </p:grpSpPr>
        <p:pic>
          <p:nvPicPr>
            <p:cNvPr id="3080" name="Picture 8" descr="C:\Users\ImageQuant\Desktop\Sonomi\Fstl1\2. NRFB\NRFB 5-1-2015\15min redo 5-5-2015\tubulin\tubulin 20150508_1150_8.tif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5678" y="6876256"/>
              <a:ext cx="3199306" cy="213287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4" name="正方形/長方形 22"/>
            <p:cNvSpPr/>
            <p:nvPr/>
          </p:nvSpPr>
          <p:spPr>
            <a:xfrm>
              <a:off x="808217" y="7625694"/>
              <a:ext cx="983649" cy="268199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テキスト ボックス 23"/>
            <p:cNvSpPr txBox="1"/>
            <p:nvPr/>
          </p:nvSpPr>
          <p:spPr>
            <a:xfrm>
              <a:off x="530900" y="7355758"/>
              <a:ext cx="7239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220520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9597011"/>
              </p:ext>
            </p:extLst>
          </p:nvPr>
        </p:nvGraphicFramePr>
        <p:xfrm>
          <a:off x="188640" y="611560"/>
          <a:ext cx="6480721" cy="381641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98302"/>
                <a:gridCol w="398302"/>
                <a:gridCol w="497879"/>
                <a:gridCol w="591231"/>
                <a:gridCol w="497879"/>
                <a:gridCol w="611975"/>
                <a:gridCol w="497879"/>
                <a:gridCol w="497879"/>
                <a:gridCol w="497879"/>
                <a:gridCol w="497879"/>
                <a:gridCol w="497879"/>
                <a:gridCol w="497879"/>
                <a:gridCol w="497879"/>
              </a:tblGrid>
              <a:tr h="169909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Figure 7A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Relative intensity p-ERK1/2 /ERK1/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Hours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/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.8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0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0.4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.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0.3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0.5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.9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0.3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0.3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69909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Figure 7B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Relative intensity p-ERK1/2 /ERK1/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rFstl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P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rFstl1+P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.904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0.174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0.12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.99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0.75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0.66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.905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0.77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0.66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69909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Figure 7C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ell migrated area (%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si con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7.378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2.297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4.2912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1.81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7.392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6.280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6.933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5.207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6.45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1.40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si Fstl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1.2383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4.937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4.42825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5.125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4.595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8.82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5.278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7.803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5.786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5.26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69909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Figure 7D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ell migrated area (%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i Fstl1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contro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0.882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1.7913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2.164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0.068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1.262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8.104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6.084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6.35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9.610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rec Fstl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1.15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2.191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4.52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2.77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4.45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38.665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34.29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5.094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</a:tr>
              <a:tr h="15683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0" marR="5750" marT="575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rec Fstl1+PD9805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1.64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8.4993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9.125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8.17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5.9388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5.855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8.416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50" marR="5750" marT="575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670870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</TotalTime>
  <Words>124</Words>
  <Application>Microsoft Office PowerPoint</Application>
  <PresentationFormat>On-screen Show (4:3)</PresentationFormat>
  <Paragraphs>10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ＭＳ Ｐゴシック</vt:lpstr>
      <vt:lpstr>Arial</vt:lpstr>
      <vt:lpstr>Calibri</vt:lpstr>
      <vt:lpstr>Office テーマ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onomi</dc:creator>
  <cp:lastModifiedBy>Whittaker, Linda D</cp:lastModifiedBy>
  <cp:revision>88</cp:revision>
  <dcterms:modified xsi:type="dcterms:W3CDTF">2016-04-22T18:41:34Z</dcterms:modified>
</cp:coreProperties>
</file>